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4" r:id="rId2"/>
  </p:sldIdLst>
  <p:sldSz cx="10680700" cy="7289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96" userDrawn="1">
          <p15:clr>
            <a:srgbClr val="A4A3A4"/>
          </p15:clr>
        </p15:guide>
        <p15:guide id="2" pos="33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8"/>
  </p:normalViewPr>
  <p:slideViewPr>
    <p:cSldViewPr snapToGrid="0" showGuides="1">
      <p:cViewPr varScale="1">
        <p:scale>
          <a:sx n="112" d="100"/>
          <a:sy n="112" d="100"/>
        </p:scale>
        <p:origin x="1104" y="192"/>
      </p:cViewPr>
      <p:guideLst>
        <p:guide orient="horz" pos="2296"/>
        <p:guide pos="33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814D77-5CFF-584B-9CA7-5AA3B5A02D2B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8400" y="1143000"/>
            <a:ext cx="4521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BCD2F7-F2A8-B74F-9565-41D7B524D53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00695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>
          <a:xfrm>
            <a:off x="1168400" y="1143000"/>
            <a:ext cx="4521200" cy="3086100"/>
          </a:xfrm>
        </p:spPr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EA4AEF4-1C09-423D-9EF0-4DDE1184975D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629004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053" y="1193030"/>
            <a:ext cx="9078595" cy="2537930"/>
          </a:xfrm>
        </p:spPr>
        <p:txBody>
          <a:bodyPr anchor="b"/>
          <a:lstStyle>
            <a:lvl1pPr algn="ctr"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5088" y="3828833"/>
            <a:ext cx="8010525" cy="1760014"/>
          </a:xfrm>
        </p:spPr>
        <p:txBody>
          <a:bodyPr/>
          <a:lstStyle>
            <a:lvl1pPr marL="0" indent="0" algn="ctr">
              <a:buNone/>
              <a:defRPr sz="2551"/>
            </a:lvl1pPr>
            <a:lvl2pPr marL="486004" indent="0" algn="ctr">
              <a:buNone/>
              <a:defRPr sz="2126"/>
            </a:lvl2pPr>
            <a:lvl3pPr marL="972007" indent="0" algn="ctr">
              <a:buNone/>
              <a:defRPr sz="1913"/>
            </a:lvl3pPr>
            <a:lvl4pPr marL="1458011" indent="0" algn="ctr">
              <a:buNone/>
              <a:defRPr sz="1701"/>
            </a:lvl4pPr>
            <a:lvl5pPr marL="1944014" indent="0" algn="ctr">
              <a:buNone/>
              <a:defRPr sz="1701"/>
            </a:lvl5pPr>
            <a:lvl6pPr marL="2430018" indent="0" algn="ctr">
              <a:buNone/>
              <a:defRPr sz="1701"/>
            </a:lvl6pPr>
            <a:lvl7pPr marL="2916022" indent="0" algn="ctr">
              <a:buNone/>
              <a:defRPr sz="1701"/>
            </a:lvl7pPr>
            <a:lvl8pPr marL="3402025" indent="0" algn="ctr">
              <a:buNone/>
              <a:defRPr sz="1701"/>
            </a:lvl8pPr>
            <a:lvl9pPr marL="3888029" indent="0" algn="ctr">
              <a:buNone/>
              <a:defRPr sz="170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52662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380928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43376" y="388114"/>
            <a:ext cx="2303026" cy="61777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4299" y="388114"/>
            <a:ext cx="6775569" cy="61777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54873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53427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8736" y="1817390"/>
            <a:ext cx="9212104" cy="3032354"/>
          </a:xfrm>
        </p:spPr>
        <p:txBody>
          <a:bodyPr anchor="b"/>
          <a:lstStyle>
            <a:lvl1pPr>
              <a:defRPr sz="637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8736" y="4878431"/>
            <a:ext cx="9212104" cy="1594643"/>
          </a:xfrm>
        </p:spPr>
        <p:txBody>
          <a:bodyPr/>
          <a:lstStyle>
            <a:lvl1pPr marL="0" indent="0">
              <a:buNone/>
              <a:defRPr sz="2551">
                <a:solidFill>
                  <a:schemeClr val="tx1"/>
                </a:solidFill>
              </a:defRPr>
            </a:lvl1pPr>
            <a:lvl2pPr marL="486004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2pPr>
            <a:lvl3pPr marL="972007" indent="0">
              <a:buNone/>
              <a:defRPr sz="1913">
                <a:solidFill>
                  <a:schemeClr val="tx1">
                    <a:tint val="75000"/>
                  </a:schemeClr>
                </a:solidFill>
              </a:defRPr>
            </a:lvl3pPr>
            <a:lvl4pPr marL="1458011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4pPr>
            <a:lvl5pPr marL="1944014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5pPr>
            <a:lvl6pPr marL="2430018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6pPr>
            <a:lvl7pPr marL="2916022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7pPr>
            <a:lvl8pPr marL="3402025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8pPr>
            <a:lvl9pPr marL="3888029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709231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4298" y="1940572"/>
            <a:ext cx="4539298" cy="46253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07104" y="1940572"/>
            <a:ext cx="4539298" cy="46253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62653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5689" y="388116"/>
            <a:ext cx="9212104" cy="140902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5690" y="1787014"/>
            <a:ext cx="4518436" cy="875788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5690" y="2662802"/>
            <a:ext cx="4518436" cy="39165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07105" y="1787014"/>
            <a:ext cx="4540689" cy="875788"/>
          </a:xfrm>
        </p:spPr>
        <p:txBody>
          <a:bodyPr anchor="b"/>
          <a:lstStyle>
            <a:lvl1pPr marL="0" indent="0">
              <a:buNone/>
              <a:defRPr sz="2551" b="1"/>
            </a:lvl1pPr>
            <a:lvl2pPr marL="486004" indent="0">
              <a:buNone/>
              <a:defRPr sz="2126" b="1"/>
            </a:lvl2pPr>
            <a:lvl3pPr marL="972007" indent="0">
              <a:buNone/>
              <a:defRPr sz="1913" b="1"/>
            </a:lvl3pPr>
            <a:lvl4pPr marL="1458011" indent="0">
              <a:buNone/>
              <a:defRPr sz="1701" b="1"/>
            </a:lvl4pPr>
            <a:lvl5pPr marL="1944014" indent="0">
              <a:buNone/>
              <a:defRPr sz="1701" b="1"/>
            </a:lvl5pPr>
            <a:lvl6pPr marL="2430018" indent="0">
              <a:buNone/>
              <a:defRPr sz="1701" b="1"/>
            </a:lvl6pPr>
            <a:lvl7pPr marL="2916022" indent="0">
              <a:buNone/>
              <a:defRPr sz="1701" b="1"/>
            </a:lvl7pPr>
            <a:lvl8pPr marL="3402025" indent="0">
              <a:buNone/>
              <a:defRPr sz="1701" b="1"/>
            </a:lvl8pPr>
            <a:lvl9pPr marL="3888029" indent="0">
              <a:buNone/>
              <a:defRPr sz="170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07105" y="2662802"/>
            <a:ext cx="4540689" cy="391658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27809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42428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4575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5689" y="485987"/>
            <a:ext cx="3444804" cy="1700953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40689" y="1049598"/>
            <a:ext cx="5407104" cy="5180483"/>
          </a:xfrm>
        </p:spPr>
        <p:txBody>
          <a:bodyPr/>
          <a:lstStyle>
            <a:lvl1pPr>
              <a:defRPr sz="3402"/>
            </a:lvl1pPr>
            <a:lvl2pPr>
              <a:defRPr sz="2976"/>
            </a:lvl2pPr>
            <a:lvl3pPr>
              <a:defRPr sz="2551"/>
            </a:lvl3pPr>
            <a:lvl4pPr>
              <a:defRPr sz="2126"/>
            </a:lvl4pPr>
            <a:lvl5pPr>
              <a:defRPr sz="2126"/>
            </a:lvl5pPr>
            <a:lvl6pPr>
              <a:defRPr sz="2126"/>
            </a:lvl6pPr>
            <a:lvl7pPr>
              <a:defRPr sz="2126"/>
            </a:lvl7pPr>
            <a:lvl8pPr>
              <a:defRPr sz="2126"/>
            </a:lvl8pPr>
            <a:lvl9pPr>
              <a:defRPr sz="212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5689" y="2186940"/>
            <a:ext cx="3444804" cy="4051577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149449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5689" y="485987"/>
            <a:ext cx="3444804" cy="1700953"/>
          </a:xfrm>
        </p:spPr>
        <p:txBody>
          <a:bodyPr anchor="b"/>
          <a:lstStyle>
            <a:lvl1pPr>
              <a:defRPr sz="340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40689" y="1049598"/>
            <a:ext cx="5407104" cy="5180483"/>
          </a:xfrm>
        </p:spPr>
        <p:txBody>
          <a:bodyPr anchor="t"/>
          <a:lstStyle>
            <a:lvl1pPr marL="0" indent="0">
              <a:buNone/>
              <a:defRPr sz="3402"/>
            </a:lvl1pPr>
            <a:lvl2pPr marL="486004" indent="0">
              <a:buNone/>
              <a:defRPr sz="2976"/>
            </a:lvl2pPr>
            <a:lvl3pPr marL="972007" indent="0">
              <a:buNone/>
              <a:defRPr sz="2551"/>
            </a:lvl3pPr>
            <a:lvl4pPr marL="1458011" indent="0">
              <a:buNone/>
              <a:defRPr sz="2126"/>
            </a:lvl4pPr>
            <a:lvl5pPr marL="1944014" indent="0">
              <a:buNone/>
              <a:defRPr sz="2126"/>
            </a:lvl5pPr>
            <a:lvl6pPr marL="2430018" indent="0">
              <a:buNone/>
              <a:defRPr sz="2126"/>
            </a:lvl6pPr>
            <a:lvl7pPr marL="2916022" indent="0">
              <a:buNone/>
              <a:defRPr sz="2126"/>
            </a:lvl7pPr>
            <a:lvl8pPr marL="3402025" indent="0">
              <a:buNone/>
              <a:defRPr sz="2126"/>
            </a:lvl8pPr>
            <a:lvl9pPr marL="3888029" indent="0">
              <a:buNone/>
              <a:defRPr sz="212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5689" y="2186940"/>
            <a:ext cx="3444804" cy="4051577"/>
          </a:xfrm>
        </p:spPr>
        <p:txBody>
          <a:bodyPr/>
          <a:lstStyle>
            <a:lvl1pPr marL="0" indent="0">
              <a:buNone/>
              <a:defRPr sz="1701"/>
            </a:lvl1pPr>
            <a:lvl2pPr marL="486004" indent="0">
              <a:buNone/>
              <a:defRPr sz="1488"/>
            </a:lvl2pPr>
            <a:lvl3pPr marL="972007" indent="0">
              <a:buNone/>
              <a:defRPr sz="1276"/>
            </a:lvl3pPr>
            <a:lvl4pPr marL="1458011" indent="0">
              <a:buNone/>
              <a:defRPr sz="1063"/>
            </a:lvl4pPr>
            <a:lvl5pPr marL="1944014" indent="0">
              <a:buNone/>
              <a:defRPr sz="1063"/>
            </a:lvl5pPr>
            <a:lvl6pPr marL="2430018" indent="0">
              <a:buNone/>
              <a:defRPr sz="1063"/>
            </a:lvl6pPr>
            <a:lvl7pPr marL="2916022" indent="0">
              <a:buNone/>
              <a:defRPr sz="1063"/>
            </a:lvl7pPr>
            <a:lvl8pPr marL="3402025" indent="0">
              <a:buNone/>
              <a:defRPr sz="1063"/>
            </a:lvl8pPr>
            <a:lvl9pPr marL="3888029" indent="0">
              <a:buNone/>
              <a:defRPr sz="10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50757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4298" y="388116"/>
            <a:ext cx="9212104" cy="140902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4298" y="1940572"/>
            <a:ext cx="9212104" cy="46253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4298" y="6756566"/>
            <a:ext cx="2403158" cy="388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F211D-22B1-2445-BB33-6066823F3B33}" type="datetimeFigureOut">
              <a:rPr lang="en-JP" smtClean="0"/>
              <a:t>2023/12/04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37982" y="6756566"/>
            <a:ext cx="3604736" cy="388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43244" y="6756566"/>
            <a:ext cx="2403158" cy="3881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B1CCB-6703-1D4E-BBC1-026475C9C37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92506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72007" rtl="0" eaLnBrk="1" latinLnBrk="0" hangingPunct="1">
        <a:lnSpc>
          <a:spcPct val="90000"/>
        </a:lnSpc>
        <a:spcBef>
          <a:spcPct val="0"/>
        </a:spcBef>
        <a:buNone/>
        <a:defRPr sz="467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002" indent="-243002" algn="l" defTabSz="972007" rtl="0" eaLnBrk="1" latinLnBrk="0" hangingPunct="1">
        <a:lnSpc>
          <a:spcPct val="90000"/>
        </a:lnSpc>
        <a:spcBef>
          <a:spcPts val="1063"/>
        </a:spcBef>
        <a:buFont typeface="Arial" panose="020B0604020202020204" pitchFamily="34" charset="0"/>
        <a:buChar char="•"/>
        <a:defRPr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29005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15009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70101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2187016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673020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3159023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645027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4131031" indent="-243002" algn="l" defTabSz="972007" rtl="0" eaLnBrk="1" latinLnBrk="0" hangingPunct="1">
        <a:lnSpc>
          <a:spcPct val="90000"/>
        </a:lnSpc>
        <a:spcBef>
          <a:spcPts val="532"/>
        </a:spcBef>
        <a:buFont typeface="Arial" panose="020B0604020202020204" pitchFamily="34" charset="0"/>
        <a:buChar char="•"/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1pPr>
      <a:lvl2pPr marL="48600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2pPr>
      <a:lvl3pPr marL="972007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3pPr>
      <a:lvl4pPr marL="1458011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4pPr>
      <a:lvl5pPr marL="1944014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5pPr>
      <a:lvl6pPr marL="2430018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6pPr>
      <a:lvl7pPr marL="2916022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7pPr>
      <a:lvl8pPr marL="3402025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8pPr>
      <a:lvl9pPr marL="3888029" algn="l" defTabSz="972007" rtl="0" eaLnBrk="1" latinLnBrk="0" hangingPunct="1">
        <a:defRPr sz="19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正方形/長方形 217">
            <a:extLst>
              <a:ext uri="{FF2B5EF4-FFF2-40B4-BE49-F238E27FC236}">
                <a16:creationId xmlns:a16="http://schemas.microsoft.com/office/drawing/2014/main" id="{12A65E7E-A39F-4239-B629-3FE71964BB48}"/>
              </a:ext>
            </a:extLst>
          </p:cNvPr>
          <p:cNvSpPr/>
          <p:nvPr/>
        </p:nvSpPr>
        <p:spPr>
          <a:xfrm>
            <a:off x="2417738" y="3490042"/>
            <a:ext cx="864096" cy="47852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12A65E7E-A39F-4239-B629-3FE71964BB48}"/>
              </a:ext>
            </a:extLst>
          </p:cNvPr>
          <p:cNvSpPr/>
          <p:nvPr/>
        </p:nvSpPr>
        <p:spPr>
          <a:xfrm>
            <a:off x="1481634" y="4050848"/>
            <a:ext cx="1800200" cy="60216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12A65E7E-A39F-4239-B629-3FE71964BB48}"/>
              </a:ext>
            </a:extLst>
          </p:cNvPr>
          <p:cNvSpPr/>
          <p:nvPr/>
        </p:nvSpPr>
        <p:spPr>
          <a:xfrm>
            <a:off x="1481634" y="3492623"/>
            <a:ext cx="864096" cy="4676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66" name="Picture 2" descr="C:\Users\かなこ\Desktop\IMG_0947.JPG"/>
          <p:cNvPicPr>
            <a:picLocks noChangeAspect="1" noChangeArrowheads="1"/>
          </p:cNvPicPr>
          <p:nvPr/>
        </p:nvPicPr>
        <p:blipFill>
          <a:blip r:embed="rId3" cstate="print"/>
          <a:srcRect l="22422" r="24544"/>
          <a:stretch>
            <a:fillRect/>
          </a:stretch>
        </p:blipFill>
        <p:spPr bwMode="auto">
          <a:xfrm>
            <a:off x="5946130" y="869536"/>
            <a:ext cx="2520280" cy="6204364"/>
          </a:xfrm>
          <a:prstGeom prst="rect">
            <a:avLst/>
          </a:prstGeom>
          <a:noFill/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29C21FE-89DC-45B8-8E15-FEE4EDC3659E}"/>
              </a:ext>
            </a:extLst>
          </p:cNvPr>
          <p:cNvSpPr/>
          <p:nvPr/>
        </p:nvSpPr>
        <p:spPr>
          <a:xfrm>
            <a:off x="8524608" y="298312"/>
            <a:ext cx="1272665" cy="68229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Ventilation</a:t>
            </a:r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8960B184-81E0-4990-8756-2F4683720E5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6787017" y="980873"/>
            <a:ext cx="2183180" cy="1272666"/>
          </a:xfrm>
          <a:prstGeom prst="bentConnector3">
            <a:avLst>
              <a:gd name="adj1" fmla="val 100666"/>
            </a:avLst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AF977A3F-84E6-4927-B00E-263A4FEB431F}"/>
              </a:ext>
            </a:extLst>
          </p:cNvPr>
          <p:cNvCxnSpPr/>
          <p:nvPr/>
        </p:nvCxnSpPr>
        <p:spPr>
          <a:xfrm>
            <a:off x="6892618" y="2929603"/>
            <a:ext cx="1696064" cy="737420"/>
          </a:xfrm>
          <a:prstGeom prst="bentConnector3">
            <a:avLst>
              <a:gd name="adj1" fmla="val 90870"/>
            </a:avLst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52ECF5E6-F686-484B-A853-AE9BFE671EB7}"/>
              </a:ext>
            </a:extLst>
          </p:cNvPr>
          <p:cNvCxnSpPr/>
          <p:nvPr/>
        </p:nvCxnSpPr>
        <p:spPr>
          <a:xfrm flipV="1">
            <a:off x="6922119" y="3652274"/>
            <a:ext cx="1666567" cy="1371600"/>
          </a:xfrm>
          <a:prstGeom prst="bentConnector3">
            <a:avLst>
              <a:gd name="adj1" fmla="val 90708"/>
            </a:avLst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FB150114-92E8-4EE1-BB96-48E5DB029100}"/>
              </a:ext>
            </a:extLst>
          </p:cNvPr>
          <p:cNvCxnSpPr>
            <a:cxnSpLocks/>
          </p:cNvCxnSpPr>
          <p:nvPr/>
        </p:nvCxnSpPr>
        <p:spPr>
          <a:xfrm rot="10800000" flipV="1">
            <a:off x="1833926" y="2792108"/>
            <a:ext cx="5050945" cy="919163"/>
          </a:xfrm>
          <a:prstGeom prst="bentConnector3">
            <a:avLst>
              <a:gd name="adj1" fmla="val 100223"/>
            </a:avLst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3283023E-0AD6-43FB-A4F9-0B5FC9FE7372}"/>
              </a:ext>
            </a:extLst>
          </p:cNvPr>
          <p:cNvCxnSpPr>
            <a:cxnSpLocks/>
            <a:endCxn id="51" idx="0"/>
          </p:cNvCxnSpPr>
          <p:nvPr/>
        </p:nvCxnSpPr>
        <p:spPr>
          <a:xfrm rot="10800000" flipV="1">
            <a:off x="3065815" y="3284863"/>
            <a:ext cx="3093225" cy="392647"/>
          </a:xfrm>
          <a:prstGeom prst="bentConnector2">
            <a:avLst/>
          </a:prstGeom>
          <a:ln w="381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764C2077-8AF3-4F30-B10B-517F2C4AB8C8}"/>
              </a:ext>
            </a:extLst>
          </p:cNvPr>
          <p:cNvCxnSpPr/>
          <p:nvPr/>
        </p:nvCxnSpPr>
        <p:spPr>
          <a:xfrm>
            <a:off x="7246583" y="5702300"/>
            <a:ext cx="1234969" cy="396158"/>
          </a:xfrm>
          <a:prstGeom prst="bentConnector3">
            <a:avLst>
              <a:gd name="adj1" fmla="val 1037"/>
            </a:avLst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D7E742B5-40B8-4CFD-B755-C493BA059826}"/>
              </a:ext>
            </a:extLst>
          </p:cNvPr>
          <p:cNvSpPr/>
          <p:nvPr/>
        </p:nvSpPr>
        <p:spPr>
          <a:xfrm>
            <a:off x="8497953" y="5819828"/>
            <a:ext cx="1826125" cy="50405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Bladder</a:t>
            </a:r>
            <a:r>
              <a:rPr lang="ja-JP" altLang="en-US" dirty="0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ressure</a:t>
            </a:r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493B3D1A-37C7-4E5B-A062-77C049F06A2B}"/>
              </a:ext>
            </a:extLst>
          </p:cNvPr>
          <p:cNvSpPr/>
          <p:nvPr/>
        </p:nvSpPr>
        <p:spPr>
          <a:xfrm>
            <a:off x="3415586" y="3474905"/>
            <a:ext cx="1584176" cy="1152128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2" name="楕円 41">
            <a:extLst>
              <a:ext uri="{FF2B5EF4-FFF2-40B4-BE49-F238E27FC236}">
                <a16:creationId xmlns:a16="http://schemas.microsoft.com/office/drawing/2014/main" id="{B81A2D00-C9B1-49A1-B7A7-6F3DB98ECF8C}"/>
              </a:ext>
            </a:extLst>
          </p:cNvPr>
          <p:cNvSpPr/>
          <p:nvPr/>
        </p:nvSpPr>
        <p:spPr>
          <a:xfrm>
            <a:off x="4207674" y="3978961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3" name="楕円 42">
            <a:extLst>
              <a:ext uri="{FF2B5EF4-FFF2-40B4-BE49-F238E27FC236}">
                <a16:creationId xmlns:a16="http://schemas.microsoft.com/office/drawing/2014/main" id="{36FD94D1-B3C6-46E7-9FE9-E4C9B27E87C8}"/>
              </a:ext>
            </a:extLst>
          </p:cNvPr>
          <p:cNvSpPr/>
          <p:nvPr/>
        </p:nvSpPr>
        <p:spPr>
          <a:xfrm>
            <a:off x="4478764" y="3978961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4" name="楕円 43">
            <a:extLst>
              <a:ext uri="{FF2B5EF4-FFF2-40B4-BE49-F238E27FC236}">
                <a16:creationId xmlns:a16="http://schemas.microsoft.com/office/drawing/2014/main" id="{BFEAF79A-5C23-4633-8B01-08B7798DE527}"/>
              </a:ext>
            </a:extLst>
          </p:cNvPr>
          <p:cNvSpPr/>
          <p:nvPr/>
        </p:nvSpPr>
        <p:spPr>
          <a:xfrm>
            <a:off x="4751523" y="3978961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5" name="楕円 44">
            <a:extLst>
              <a:ext uri="{FF2B5EF4-FFF2-40B4-BE49-F238E27FC236}">
                <a16:creationId xmlns:a16="http://schemas.microsoft.com/office/drawing/2014/main" id="{7F71C06D-440E-4CAE-A305-7B9EFD79BAEB}"/>
              </a:ext>
            </a:extLst>
          </p:cNvPr>
          <p:cNvSpPr/>
          <p:nvPr/>
        </p:nvSpPr>
        <p:spPr>
          <a:xfrm>
            <a:off x="3905851" y="4364980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6" name="楕円 45">
            <a:extLst>
              <a:ext uri="{FF2B5EF4-FFF2-40B4-BE49-F238E27FC236}">
                <a16:creationId xmlns:a16="http://schemas.microsoft.com/office/drawing/2014/main" id="{507356AC-8967-4175-9B15-1E954AEAD9DC}"/>
              </a:ext>
            </a:extLst>
          </p:cNvPr>
          <p:cNvSpPr/>
          <p:nvPr/>
        </p:nvSpPr>
        <p:spPr>
          <a:xfrm>
            <a:off x="4164078" y="4364980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7" name="楕円 46">
            <a:extLst>
              <a:ext uri="{FF2B5EF4-FFF2-40B4-BE49-F238E27FC236}">
                <a16:creationId xmlns:a16="http://schemas.microsoft.com/office/drawing/2014/main" id="{5716C6DE-8F00-4A47-AB16-FB78E8E3D75F}"/>
              </a:ext>
            </a:extLst>
          </p:cNvPr>
          <p:cNvSpPr/>
          <p:nvPr/>
        </p:nvSpPr>
        <p:spPr>
          <a:xfrm>
            <a:off x="4459499" y="4364980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8" name="楕円 47">
            <a:extLst>
              <a:ext uri="{FF2B5EF4-FFF2-40B4-BE49-F238E27FC236}">
                <a16:creationId xmlns:a16="http://schemas.microsoft.com/office/drawing/2014/main" id="{69F597B2-9EE3-440D-A8E5-4311A5C8D01F}"/>
              </a:ext>
            </a:extLst>
          </p:cNvPr>
          <p:cNvSpPr/>
          <p:nvPr/>
        </p:nvSpPr>
        <p:spPr>
          <a:xfrm>
            <a:off x="4721994" y="4364980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" name="楕円 49">
            <a:extLst>
              <a:ext uri="{FF2B5EF4-FFF2-40B4-BE49-F238E27FC236}">
                <a16:creationId xmlns:a16="http://schemas.microsoft.com/office/drawing/2014/main" id="{46D57310-B42C-4604-ADD4-6DC76599269C}"/>
              </a:ext>
            </a:extLst>
          </p:cNvPr>
          <p:cNvSpPr/>
          <p:nvPr/>
        </p:nvSpPr>
        <p:spPr>
          <a:xfrm>
            <a:off x="1769666" y="3677507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1" name="楕円 50">
            <a:extLst>
              <a:ext uri="{FF2B5EF4-FFF2-40B4-BE49-F238E27FC236}">
                <a16:creationId xmlns:a16="http://schemas.microsoft.com/office/drawing/2014/main" id="{C100682C-719E-4C4D-91C9-C267843A0D14}"/>
              </a:ext>
            </a:extLst>
          </p:cNvPr>
          <p:cNvSpPr/>
          <p:nvPr/>
        </p:nvSpPr>
        <p:spPr>
          <a:xfrm>
            <a:off x="2993802" y="3677507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2" name="楕円 51">
            <a:extLst>
              <a:ext uri="{FF2B5EF4-FFF2-40B4-BE49-F238E27FC236}">
                <a16:creationId xmlns:a16="http://schemas.microsoft.com/office/drawing/2014/main" id="{3A6445B8-BC31-457C-9FF3-C068AA6DEFCF}"/>
              </a:ext>
            </a:extLst>
          </p:cNvPr>
          <p:cNvSpPr/>
          <p:nvPr/>
        </p:nvSpPr>
        <p:spPr>
          <a:xfrm>
            <a:off x="1769666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5" name="楕円 54">
            <a:extLst>
              <a:ext uri="{FF2B5EF4-FFF2-40B4-BE49-F238E27FC236}">
                <a16:creationId xmlns:a16="http://schemas.microsoft.com/office/drawing/2014/main" id="{6BADB43C-7F1B-4E7C-9373-D2373DC25D51}"/>
              </a:ext>
            </a:extLst>
          </p:cNvPr>
          <p:cNvSpPr/>
          <p:nvPr/>
        </p:nvSpPr>
        <p:spPr>
          <a:xfrm>
            <a:off x="2258064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6" name="楕円 55">
            <a:extLst>
              <a:ext uri="{FF2B5EF4-FFF2-40B4-BE49-F238E27FC236}">
                <a16:creationId xmlns:a16="http://schemas.microsoft.com/office/drawing/2014/main" id="{D7FA6492-7314-4CDE-97E4-F0DFEAD50F14}"/>
              </a:ext>
            </a:extLst>
          </p:cNvPr>
          <p:cNvSpPr/>
          <p:nvPr/>
        </p:nvSpPr>
        <p:spPr>
          <a:xfrm>
            <a:off x="2515486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7" name="楕円 56">
            <a:extLst>
              <a:ext uri="{FF2B5EF4-FFF2-40B4-BE49-F238E27FC236}">
                <a16:creationId xmlns:a16="http://schemas.microsoft.com/office/drawing/2014/main" id="{3C00DF0C-08D6-49F6-953E-0A9E1FEAD0BF}"/>
              </a:ext>
            </a:extLst>
          </p:cNvPr>
          <p:cNvSpPr/>
          <p:nvPr/>
        </p:nvSpPr>
        <p:spPr>
          <a:xfrm>
            <a:off x="2755362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楕円 57">
            <a:extLst>
              <a:ext uri="{FF2B5EF4-FFF2-40B4-BE49-F238E27FC236}">
                <a16:creationId xmlns:a16="http://schemas.microsoft.com/office/drawing/2014/main" id="{0B7A7DD9-75D9-47BF-9610-3771174D41BE}"/>
              </a:ext>
            </a:extLst>
          </p:cNvPr>
          <p:cNvSpPr/>
          <p:nvPr/>
        </p:nvSpPr>
        <p:spPr>
          <a:xfrm>
            <a:off x="3017857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9" name="楕円 58">
            <a:extLst>
              <a:ext uri="{FF2B5EF4-FFF2-40B4-BE49-F238E27FC236}">
                <a16:creationId xmlns:a16="http://schemas.microsoft.com/office/drawing/2014/main" id="{CB16546C-EC44-46BD-9BC1-796E9D48E8A2}"/>
              </a:ext>
            </a:extLst>
          </p:cNvPr>
          <p:cNvSpPr/>
          <p:nvPr/>
        </p:nvSpPr>
        <p:spPr>
          <a:xfrm>
            <a:off x="2009745" y="4411009"/>
            <a:ext cx="144016" cy="144016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318C2E68-A2CC-4076-8AED-A97A4E4DDA19}"/>
              </a:ext>
            </a:extLst>
          </p:cNvPr>
          <p:cNvCxnSpPr>
            <a:endCxn id="75" idx="1"/>
          </p:cNvCxnSpPr>
          <p:nvPr/>
        </p:nvCxnSpPr>
        <p:spPr>
          <a:xfrm rot="5400000" flipH="1" flipV="1">
            <a:off x="4068821" y="1107799"/>
            <a:ext cx="3185514" cy="2729346"/>
          </a:xfrm>
          <a:prstGeom prst="bentConnector2">
            <a:avLst/>
          </a:prstGeom>
          <a:ln w="3810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50C4A608-8DB1-4B7F-A9C7-328CDA7D678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4257031" y="1214500"/>
            <a:ext cx="3141326" cy="2560141"/>
          </a:xfrm>
          <a:prstGeom prst="bentConnector3">
            <a:avLst>
              <a:gd name="adj1" fmla="val 99297"/>
            </a:avLst>
          </a:prstGeom>
          <a:ln w="38100"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正方形/長方形 74">
            <a:extLst>
              <a:ext uri="{FF2B5EF4-FFF2-40B4-BE49-F238E27FC236}">
                <a16:creationId xmlns:a16="http://schemas.microsoft.com/office/drawing/2014/main" id="{B4DABC2F-6740-4192-8A01-C25084040294}"/>
              </a:ext>
            </a:extLst>
          </p:cNvPr>
          <p:cNvSpPr/>
          <p:nvPr/>
        </p:nvSpPr>
        <p:spPr>
          <a:xfrm>
            <a:off x="7026255" y="778826"/>
            <a:ext cx="360039" cy="201778"/>
          </a:xfrm>
          <a:prstGeom prst="rect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600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9C7FAA67-FF17-4020-87A5-6D59B64884FB}"/>
              </a:ext>
            </a:extLst>
          </p:cNvPr>
          <p:cNvCxnSpPr>
            <a:cxnSpLocks/>
          </p:cNvCxnSpPr>
          <p:nvPr/>
        </p:nvCxnSpPr>
        <p:spPr>
          <a:xfrm>
            <a:off x="2822067" y="3991491"/>
            <a:ext cx="14749" cy="486697"/>
          </a:xfrm>
          <a:prstGeom prst="straightConnector1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30C2A732-4441-4DBA-B834-1DBA3185D506}"/>
              </a:ext>
            </a:extLst>
          </p:cNvPr>
          <p:cNvCxnSpPr>
            <a:cxnSpLocks/>
          </p:cNvCxnSpPr>
          <p:nvPr/>
        </p:nvCxnSpPr>
        <p:spPr>
          <a:xfrm flipH="1" flipV="1">
            <a:off x="3087538" y="3740765"/>
            <a:ext cx="3471" cy="72098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CD7CA184-1EE1-4C00-84D9-EE44DDAD6076}"/>
              </a:ext>
            </a:extLst>
          </p:cNvPr>
          <p:cNvCxnSpPr>
            <a:cxnSpLocks/>
            <a:stCxn id="108" idx="0"/>
          </p:cNvCxnSpPr>
          <p:nvPr/>
        </p:nvCxnSpPr>
        <p:spPr>
          <a:xfrm rot="5400000" flipH="1" flipV="1">
            <a:off x="793719" y="4875227"/>
            <a:ext cx="1237186" cy="138643"/>
          </a:xfrm>
          <a:prstGeom prst="bentConnector2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id="{BC5B7699-0866-45D0-BF46-FF3189984E01}"/>
              </a:ext>
            </a:extLst>
          </p:cNvPr>
          <p:cNvSpPr/>
          <p:nvPr/>
        </p:nvSpPr>
        <p:spPr>
          <a:xfrm>
            <a:off x="761554" y="5563141"/>
            <a:ext cx="1162874" cy="53003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C</a:t>
            </a:r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AB97AC60-398E-43D9-8C09-EA54A4E5F648}"/>
              </a:ext>
            </a:extLst>
          </p:cNvPr>
          <p:cNvSpPr txBox="1"/>
          <p:nvPr/>
        </p:nvSpPr>
        <p:spPr>
          <a:xfrm>
            <a:off x="1416139" y="4021771"/>
            <a:ext cx="1636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OWER</a:t>
            </a:r>
            <a:r>
              <a:rPr lang="ja-JP" altLang="en-US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LAB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12DBF61C-872D-43F2-9ED1-03DD546B16C3}"/>
              </a:ext>
            </a:extLst>
          </p:cNvPr>
          <p:cNvSpPr txBox="1"/>
          <p:nvPr/>
        </p:nvSpPr>
        <p:spPr>
          <a:xfrm>
            <a:off x="4235321" y="487928"/>
            <a:ext cx="2424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irway pressure / Flow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D6E63BA5-1D81-4BEE-9212-4B203E0C5F85}"/>
              </a:ext>
            </a:extLst>
          </p:cNvPr>
          <p:cNvSpPr txBox="1"/>
          <p:nvPr/>
        </p:nvSpPr>
        <p:spPr>
          <a:xfrm>
            <a:off x="5270279" y="2395030"/>
            <a:ext cx="879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VP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26D7D711-9FAA-40E2-856B-8D89708A4A43}"/>
              </a:ext>
            </a:extLst>
          </p:cNvPr>
          <p:cNvSpPr txBox="1"/>
          <p:nvPr/>
        </p:nvSpPr>
        <p:spPr>
          <a:xfrm>
            <a:off x="4800527" y="2941326"/>
            <a:ext cx="18873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leural pressure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26E24284-57BF-400B-B6A7-52F6E6A341B3}"/>
              </a:ext>
            </a:extLst>
          </p:cNvPr>
          <p:cNvSpPr txBox="1"/>
          <p:nvPr/>
        </p:nvSpPr>
        <p:spPr>
          <a:xfrm>
            <a:off x="4721997" y="1329090"/>
            <a:ext cx="22992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Esophageal pressure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3353846" y="3203484"/>
            <a:ext cx="191969" cy="15338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3" name="正方形/長方形 62"/>
          <p:cNvSpPr/>
          <p:nvPr/>
        </p:nvSpPr>
        <p:spPr>
          <a:xfrm>
            <a:off x="3353846" y="2708796"/>
            <a:ext cx="191969" cy="15338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16" name="直線コネクタ 115">
            <a:extLst>
              <a:ext uri="{FF2B5EF4-FFF2-40B4-BE49-F238E27FC236}">
                <a16:creationId xmlns:a16="http://schemas.microsoft.com/office/drawing/2014/main" id="{5B86D960-3B76-4D56-8DF2-D4D64E111CF5}"/>
              </a:ext>
            </a:extLst>
          </p:cNvPr>
          <p:cNvCxnSpPr>
            <a:cxnSpLocks/>
          </p:cNvCxnSpPr>
          <p:nvPr/>
        </p:nvCxnSpPr>
        <p:spPr>
          <a:xfrm rot="16200000" flipV="1">
            <a:off x="5911850" y="3541661"/>
            <a:ext cx="766916" cy="280220"/>
          </a:xfrm>
          <a:prstGeom prst="bentConnector3">
            <a:avLst>
              <a:gd name="adj1" fmla="val 0"/>
            </a:avLst>
          </a:prstGeom>
          <a:ln w="3810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正方形/長方形 68">
            <a:extLst>
              <a:ext uri="{FF2B5EF4-FFF2-40B4-BE49-F238E27FC236}">
                <a16:creationId xmlns:a16="http://schemas.microsoft.com/office/drawing/2014/main" id="{C29C21FE-89DC-45B8-8E15-FEE4EDC3659E}"/>
              </a:ext>
            </a:extLst>
          </p:cNvPr>
          <p:cNvSpPr/>
          <p:nvPr/>
        </p:nvSpPr>
        <p:spPr>
          <a:xfrm>
            <a:off x="8596614" y="3356868"/>
            <a:ext cx="1021924" cy="6102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dirty="0" err="1">
                <a:solidFill>
                  <a:prstClr val="white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iCCO</a:t>
            </a:r>
            <a:endParaRPr lang="ja-JP" altLang="en-US" dirty="0">
              <a:solidFill>
                <a:prstClr val="white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33006172-C3E1-4B4B-AE50-5A1897D44D59}"/>
              </a:ext>
            </a:extLst>
          </p:cNvPr>
          <p:cNvCxnSpPr>
            <a:cxnSpLocks/>
          </p:cNvCxnSpPr>
          <p:nvPr/>
        </p:nvCxnSpPr>
        <p:spPr>
          <a:xfrm flipV="1">
            <a:off x="4813099" y="1675991"/>
            <a:ext cx="2580969" cy="2374490"/>
          </a:xfrm>
          <a:prstGeom prst="bentConnector3">
            <a:avLst>
              <a:gd name="adj1" fmla="val 286"/>
            </a:avLst>
          </a:prstGeom>
          <a:ln w="381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正方形/長方形 167"/>
          <p:cNvSpPr/>
          <p:nvPr/>
        </p:nvSpPr>
        <p:spPr>
          <a:xfrm>
            <a:off x="3425874" y="3492937"/>
            <a:ext cx="9412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SS100</a:t>
            </a:r>
            <a:endParaRPr lang="ja-JP" altLang="en-US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82" name="直線コネクタ 29">
            <a:extLst>
              <a:ext uri="{FF2B5EF4-FFF2-40B4-BE49-F238E27FC236}">
                <a16:creationId xmlns:a16="http://schemas.microsoft.com/office/drawing/2014/main" id="{33006172-C3E1-4B4B-AE50-5A1897D44D59}"/>
              </a:ext>
            </a:extLst>
          </p:cNvPr>
          <p:cNvCxnSpPr>
            <a:cxnSpLocks/>
          </p:cNvCxnSpPr>
          <p:nvPr/>
        </p:nvCxnSpPr>
        <p:spPr>
          <a:xfrm flipH="1" flipV="1">
            <a:off x="7379319" y="1661242"/>
            <a:ext cx="29497" cy="1691324"/>
          </a:xfrm>
          <a:prstGeom prst="straightConnector1">
            <a:avLst/>
          </a:prstGeom>
          <a:ln w="3810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直線コネクタ 93">
            <a:extLst>
              <a:ext uri="{FF2B5EF4-FFF2-40B4-BE49-F238E27FC236}">
                <a16:creationId xmlns:a16="http://schemas.microsoft.com/office/drawing/2014/main" id="{9C7FAA67-FF17-4020-87A5-6D59B64884FB}"/>
              </a:ext>
            </a:extLst>
          </p:cNvPr>
          <p:cNvCxnSpPr>
            <a:cxnSpLocks/>
          </p:cNvCxnSpPr>
          <p:nvPr/>
        </p:nvCxnSpPr>
        <p:spPr>
          <a:xfrm>
            <a:off x="2601694" y="4504535"/>
            <a:ext cx="2181904" cy="194879"/>
          </a:xfrm>
          <a:prstGeom prst="bentConnector3">
            <a:avLst>
              <a:gd name="adj1" fmla="val -696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1" name="グループ化 260"/>
          <p:cNvGrpSpPr/>
          <p:nvPr/>
        </p:nvGrpSpPr>
        <p:grpSpPr>
          <a:xfrm>
            <a:off x="1832230" y="4484229"/>
            <a:ext cx="2140251" cy="701881"/>
            <a:chOff x="1178176" y="4268325"/>
            <a:chExt cx="2140251" cy="701881"/>
          </a:xfrm>
        </p:grpSpPr>
        <p:cxnSp>
          <p:nvCxnSpPr>
            <p:cNvPr id="219" name="直線コネクタ 93">
              <a:extLst>
                <a:ext uri="{FF2B5EF4-FFF2-40B4-BE49-F238E27FC236}">
                  <a16:creationId xmlns:a16="http://schemas.microsoft.com/office/drawing/2014/main" id="{9C7FAA67-FF17-4020-87A5-6D59B64884FB}"/>
                </a:ext>
              </a:extLst>
            </p:cNvPr>
            <p:cNvCxnSpPr>
              <a:cxnSpLocks/>
            </p:cNvCxnSpPr>
            <p:nvPr/>
          </p:nvCxnSpPr>
          <p:spPr>
            <a:xfrm>
              <a:off x="1178176" y="4274840"/>
              <a:ext cx="2125463" cy="665870"/>
            </a:xfrm>
            <a:prstGeom prst="bentConnector3">
              <a:avLst>
                <a:gd name="adj1" fmla="val 40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線コネクタ 252">
              <a:extLst>
                <a:ext uri="{FF2B5EF4-FFF2-40B4-BE49-F238E27FC236}">
                  <a16:creationId xmlns:a16="http://schemas.microsoft.com/office/drawing/2014/main" id="{30C2A732-4441-4DBA-B834-1DBA3185D5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18387" y="4268325"/>
              <a:ext cx="40" cy="70188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54" name="直線コネクタ 253">
            <a:extLst>
              <a:ext uri="{FF2B5EF4-FFF2-40B4-BE49-F238E27FC236}">
                <a16:creationId xmlns:a16="http://schemas.microsoft.com/office/drawing/2014/main" id="{30C2A732-4441-4DBA-B834-1DBA3185D506}"/>
              </a:ext>
            </a:extLst>
          </p:cNvPr>
          <p:cNvCxnSpPr>
            <a:cxnSpLocks/>
          </p:cNvCxnSpPr>
          <p:nvPr/>
        </p:nvCxnSpPr>
        <p:spPr>
          <a:xfrm flipH="1" flipV="1">
            <a:off x="4796615" y="4459097"/>
            <a:ext cx="1732" cy="24031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6" name="グループ化 275"/>
          <p:cNvGrpSpPr/>
          <p:nvPr/>
        </p:nvGrpSpPr>
        <p:grpSpPr>
          <a:xfrm>
            <a:off x="2316356" y="4492932"/>
            <a:ext cx="2216527" cy="368714"/>
            <a:chOff x="1662302" y="4277032"/>
            <a:chExt cx="2216527" cy="368714"/>
          </a:xfrm>
        </p:grpSpPr>
        <p:cxnSp>
          <p:nvCxnSpPr>
            <p:cNvPr id="231" name="直線コネクタ 93">
              <a:extLst>
                <a:ext uri="{FF2B5EF4-FFF2-40B4-BE49-F238E27FC236}">
                  <a16:creationId xmlns:a16="http://schemas.microsoft.com/office/drawing/2014/main" id="{9C7FAA67-FF17-4020-87A5-6D59B64884FB}"/>
                </a:ext>
              </a:extLst>
            </p:cNvPr>
            <p:cNvCxnSpPr>
              <a:cxnSpLocks/>
            </p:cNvCxnSpPr>
            <p:nvPr/>
          </p:nvCxnSpPr>
          <p:spPr>
            <a:xfrm>
              <a:off x="1662302" y="4289336"/>
              <a:ext cx="2202307" cy="348972"/>
            </a:xfrm>
            <a:prstGeom prst="bentConnector3">
              <a:avLst>
                <a:gd name="adj1" fmla="val 444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直線コネクタ 254">
              <a:extLst>
                <a:ext uri="{FF2B5EF4-FFF2-40B4-BE49-F238E27FC236}">
                  <a16:creationId xmlns:a16="http://schemas.microsoft.com/office/drawing/2014/main" id="{30C2A732-4441-4DBA-B834-1DBA3185D50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878826" y="4277032"/>
              <a:ext cx="3" cy="36871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7" name="グループ化 266"/>
          <p:cNvGrpSpPr/>
          <p:nvPr/>
        </p:nvGrpSpPr>
        <p:grpSpPr>
          <a:xfrm>
            <a:off x="2074890" y="4485126"/>
            <a:ext cx="2177766" cy="479759"/>
            <a:chOff x="1420840" y="4269222"/>
            <a:chExt cx="2177766" cy="479759"/>
          </a:xfrm>
        </p:grpSpPr>
        <p:cxnSp>
          <p:nvCxnSpPr>
            <p:cNvPr id="230" name="直線コネクタ 93">
              <a:extLst>
                <a:ext uri="{FF2B5EF4-FFF2-40B4-BE49-F238E27FC236}">
                  <a16:creationId xmlns:a16="http://schemas.microsoft.com/office/drawing/2014/main" id="{9C7FAA67-FF17-4020-87A5-6D59B64884FB}"/>
                </a:ext>
              </a:extLst>
            </p:cNvPr>
            <p:cNvCxnSpPr>
              <a:cxnSpLocks/>
            </p:cNvCxnSpPr>
            <p:nvPr/>
          </p:nvCxnSpPr>
          <p:spPr>
            <a:xfrm>
              <a:off x="1420840" y="4294046"/>
              <a:ext cx="2177766" cy="454935"/>
            </a:xfrm>
            <a:prstGeom prst="bentConnector3">
              <a:avLst>
                <a:gd name="adj1" fmla="val 563"/>
              </a:avLst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直線コネクタ 255">
              <a:extLst>
                <a:ext uri="{FF2B5EF4-FFF2-40B4-BE49-F238E27FC236}">
                  <a16:creationId xmlns:a16="http://schemas.microsoft.com/office/drawing/2014/main" id="{30C2A732-4441-4DBA-B834-1DBA3185D5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83857" y="4269222"/>
              <a:ext cx="1" cy="479759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27" name="直線コネクタ 93">
            <a:extLst>
              <a:ext uri="{FF2B5EF4-FFF2-40B4-BE49-F238E27FC236}">
                <a16:creationId xmlns:a16="http://schemas.microsoft.com/office/drawing/2014/main" id="{9C7FAA67-FF17-4020-87A5-6D59B64884FB}"/>
              </a:ext>
            </a:extLst>
          </p:cNvPr>
          <p:cNvCxnSpPr>
            <a:cxnSpLocks/>
          </p:cNvCxnSpPr>
          <p:nvPr/>
        </p:nvCxnSpPr>
        <p:spPr>
          <a:xfrm>
            <a:off x="1841678" y="3788920"/>
            <a:ext cx="980389" cy="217319"/>
          </a:xfrm>
          <a:prstGeom prst="bentConnector3">
            <a:avLst>
              <a:gd name="adj1" fmla="val -1148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0" name="直線矢印コネクタ 339"/>
          <p:cNvCxnSpPr/>
          <p:nvPr/>
        </p:nvCxnSpPr>
        <p:spPr>
          <a:xfrm flipH="1" flipV="1">
            <a:off x="3235041" y="5156152"/>
            <a:ext cx="694869" cy="91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1" name="直線矢印コネクタ 340"/>
          <p:cNvCxnSpPr/>
          <p:nvPr/>
        </p:nvCxnSpPr>
        <p:spPr>
          <a:xfrm flipH="1">
            <a:off x="3229856" y="4971777"/>
            <a:ext cx="79208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2" name="直線矢印コネクタ 341"/>
          <p:cNvCxnSpPr/>
          <p:nvPr/>
        </p:nvCxnSpPr>
        <p:spPr>
          <a:xfrm flipH="1">
            <a:off x="3568802" y="4860858"/>
            <a:ext cx="79208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3" name="直線矢印コネクタ 342"/>
          <p:cNvCxnSpPr/>
          <p:nvPr/>
        </p:nvCxnSpPr>
        <p:spPr>
          <a:xfrm flipH="1">
            <a:off x="3576557" y="4696931"/>
            <a:ext cx="792088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4" name="直線矢印コネクタ 343"/>
          <p:cNvCxnSpPr/>
          <p:nvPr/>
        </p:nvCxnSpPr>
        <p:spPr>
          <a:xfrm>
            <a:off x="3073722" y="3847451"/>
            <a:ext cx="8384" cy="5124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6" name="直線矢印コネクタ 345"/>
          <p:cNvCxnSpPr/>
          <p:nvPr/>
        </p:nvCxnSpPr>
        <p:spPr>
          <a:xfrm>
            <a:off x="2822063" y="4011437"/>
            <a:ext cx="0" cy="36004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0" name="直線矢印コネクタ 349"/>
          <p:cNvCxnSpPr/>
          <p:nvPr/>
        </p:nvCxnSpPr>
        <p:spPr>
          <a:xfrm>
            <a:off x="1345490" y="4662100"/>
            <a:ext cx="8384" cy="51244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6111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</TotalTime>
  <Words>18</Words>
  <Application>Microsoft Macintosh PowerPoint</Application>
  <PresentationFormat>Custom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京極 都</dc:creator>
  <cp:lastModifiedBy>京極 都</cp:lastModifiedBy>
  <cp:revision>1</cp:revision>
  <dcterms:created xsi:type="dcterms:W3CDTF">2023-12-03T15:49:21Z</dcterms:created>
  <dcterms:modified xsi:type="dcterms:W3CDTF">2023-12-03T15:52:23Z</dcterms:modified>
</cp:coreProperties>
</file>